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0F9056-6276-4C1B-98F6-74AB185D1837}" v="55" dt="2023-03-09T21:50:51.9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68" autoAdjust="0"/>
    <p:restoredTop sz="94660"/>
  </p:normalViewPr>
  <p:slideViewPr>
    <p:cSldViewPr snapToGrid="0">
      <p:cViewPr varScale="1">
        <p:scale>
          <a:sx n="99" d="100"/>
          <a:sy n="99" d="100"/>
        </p:scale>
        <p:origin x="102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79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914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58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602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277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585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968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95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484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102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688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10690-5521-4F56-9D0D-CE8714F9E50B}" type="datetimeFigureOut">
              <a:rPr lang="en-US" smtClean="0"/>
              <a:t>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4DB54-1963-4B65-9587-1B9E4C90F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038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w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wmf"/><Relationship Id="rId21" Type="http://schemas.openxmlformats.org/officeDocument/2006/relationships/image" Target="../media/image10.wmf"/><Relationship Id="rId7" Type="http://schemas.openxmlformats.org/officeDocument/2006/relationships/image" Target="../media/image3.w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w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wmf"/><Relationship Id="rId5" Type="http://schemas.openxmlformats.org/officeDocument/2006/relationships/image" Target="../media/image2.wmf"/><Relationship Id="rId15" Type="http://schemas.openxmlformats.org/officeDocument/2006/relationships/image" Target="../media/image7.w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w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C702ADE-DA95-3965-053E-AF37DD9D71FE}"/>
              </a:ext>
            </a:extLst>
          </p:cNvPr>
          <p:cNvSpPr txBox="1"/>
          <p:nvPr/>
        </p:nvSpPr>
        <p:spPr>
          <a:xfrm>
            <a:off x="440064" y="76717"/>
            <a:ext cx="3552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blot/gel for Figure 1 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BD8410-B51D-90EA-2B8A-4A124D87841B}"/>
              </a:ext>
            </a:extLst>
          </p:cNvPr>
          <p:cNvSpPr txBox="1"/>
          <p:nvPr/>
        </p:nvSpPr>
        <p:spPr>
          <a:xfrm>
            <a:off x="3813640" y="578260"/>
            <a:ext cx="846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MDM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A661F8C-0602-496E-C9B0-694C046B1A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9867064"/>
              </p:ext>
            </p:extLst>
          </p:nvPr>
        </p:nvGraphicFramePr>
        <p:xfrm>
          <a:off x="921673" y="1035759"/>
          <a:ext cx="1635480" cy="2306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743400" imgH="1048320" progId="">
                  <p:embed/>
                </p:oleObj>
              </mc:Choice>
              <mc:Fallback>
                <p:oleObj r:id="rId2" imgW="743400" imgH="1048320" progId="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A661F8C-0602-496E-C9B0-694C046B1A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21673" y="1035759"/>
                        <a:ext cx="1635480" cy="2306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EC77853-6DCE-E2F4-7C32-61D7880B06F6}"/>
              </a:ext>
            </a:extLst>
          </p:cNvPr>
          <p:cNvSpPr txBox="1"/>
          <p:nvPr/>
        </p:nvSpPr>
        <p:spPr>
          <a:xfrm>
            <a:off x="302216" y="2487479"/>
            <a:ext cx="835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38B4EDC-499D-9C71-98F8-4F9C67ABB57C}"/>
              </a:ext>
            </a:extLst>
          </p:cNvPr>
          <p:cNvSpPr/>
          <p:nvPr/>
        </p:nvSpPr>
        <p:spPr>
          <a:xfrm>
            <a:off x="1875295" y="2309246"/>
            <a:ext cx="681858" cy="4339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490BEE-3D99-05C4-4206-2EABB23588CB}"/>
              </a:ext>
            </a:extLst>
          </p:cNvPr>
          <p:cNvSpPr txBox="1"/>
          <p:nvPr/>
        </p:nvSpPr>
        <p:spPr>
          <a:xfrm>
            <a:off x="2612278" y="2309246"/>
            <a:ext cx="9509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Zfhx3</a:t>
            </a:r>
          </a:p>
          <a:p>
            <a:r>
              <a:rPr lang="en-US" dirty="0"/>
              <a:t>&gt;400 </a:t>
            </a:r>
            <a:r>
              <a:rPr lang="en-US" dirty="0" err="1"/>
              <a:t>kD</a:t>
            </a:r>
            <a:endParaRPr lang="en-US" dirty="0"/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8CF5AC3-08EF-0E5E-1FB3-6EEFA97F76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3086703"/>
              </p:ext>
            </p:extLst>
          </p:nvPr>
        </p:nvGraphicFramePr>
        <p:xfrm>
          <a:off x="3941763" y="1217613"/>
          <a:ext cx="719137" cy="303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719280" imgH="303120" progId="">
                  <p:embed/>
                </p:oleObj>
              </mc:Choice>
              <mc:Fallback>
                <p:oleObj r:id="rId4" imgW="719280" imgH="303120" progId="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C8CF5AC3-08EF-0E5E-1FB3-6EEFA97F76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41763" y="1217613"/>
                        <a:ext cx="719137" cy="303212"/>
                      </a:xfrm>
                      <a:prstGeom prst="rect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10C1BE0-343B-F6A7-7914-2F75A7F690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5080003"/>
              </p:ext>
            </p:extLst>
          </p:nvPr>
        </p:nvGraphicFramePr>
        <p:xfrm>
          <a:off x="6296943" y="711872"/>
          <a:ext cx="852487" cy="296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853200" imgH="2962080" progId="">
                  <p:embed/>
                </p:oleObj>
              </mc:Choice>
              <mc:Fallback>
                <p:oleObj r:id="rId6" imgW="853200" imgH="2962080" progId="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610C1BE0-343B-F6A7-7914-2F75A7F690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96943" y="711872"/>
                        <a:ext cx="852487" cy="296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B24A643-E255-AF9B-9A47-A7623DEC3F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5095486"/>
              </p:ext>
            </p:extLst>
          </p:nvPr>
        </p:nvGraphicFramePr>
        <p:xfrm>
          <a:off x="3946662" y="1565670"/>
          <a:ext cx="719137" cy="327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719280" imgH="327600" progId="">
                  <p:embed/>
                </p:oleObj>
              </mc:Choice>
              <mc:Fallback>
                <p:oleObj r:id="rId8" imgW="719280" imgH="327600" progId="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2B24A643-E255-AF9B-9A47-A7623DEC3F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46662" y="1565670"/>
                        <a:ext cx="719137" cy="32702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52AEACF9-7141-62A6-2B95-AA08411B0CD0}"/>
              </a:ext>
            </a:extLst>
          </p:cNvPr>
          <p:cNvSpPr txBox="1"/>
          <p:nvPr/>
        </p:nvSpPr>
        <p:spPr>
          <a:xfrm>
            <a:off x="7221904" y="1763656"/>
            <a:ext cx="8338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actin</a:t>
            </a:r>
          </a:p>
          <a:p>
            <a:r>
              <a:rPr lang="en-US" dirty="0"/>
              <a:t>~42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AA355DA-B282-C21C-797F-22C33CE8A0C0}"/>
              </a:ext>
            </a:extLst>
          </p:cNvPr>
          <p:cNvSpPr txBox="1"/>
          <p:nvPr/>
        </p:nvSpPr>
        <p:spPr>
          <a:xfrm>
            <a:off x="5465062" y="851411"/>
            <a:ext cx="835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6232B6-6C32-3AAF-7BCB-B4B6758E7F06}"/>
              </a:ext>
            </a:extLst>
          </p:cNvPr>
          <p:cNvSpPr txBox="1"/>
          <p:nvPr/>
        </p:nvSpPr>
        <p:spPr>
          <a:xfrm>
            <a:off x="5461458" y="1671033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B097E04-EBB6-378D-76F1-43B786CF45C2}"/>
              </a:ext>
            </a:extLst>
          </p:cNvPr>
          <p:cNvSpPr txBox="1"/>
          <p:nvPr/>
        </p:nvSpPr>
        <p:spPr>
          <a:xfrm>
            <a:off x="5461458" y="1893447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7F3D419-F776-1E77-47FA-C223495D1D71}"/>
              </a:ext>
            </a:extLst>
          </p:cNvPr>
          <p:cNvSpPr txBox="1"/>
          <p:nvPr/>
        </p:nvSpPr>
        <p:spPr>
          <a:xfrm>
            <a:off x="281331" y="4919213"/>
            <a:ext cx="835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0 </a:t>
            </a:r>
            <a:r>
              <a:rPr lang="en-US" dirty="0" err="1"/>
              <a:t>kD</a:t>
            </a:r>
            <a:endParaRPr lang="en-US" dirty="0"/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5382CC82-B391-636A-AAAB-1282506B0B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4732792"/>
              </p:ext>
            </p:extLst>
          </p:nvPr>
        </p:nvGraphicFramePr>
        <p:xfrm>
          <a:off x="1055866" y="4388644"/>
          <a:ext cx="938213" cy="181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938520" imgH="1816200" progId="">
                  <p:embed/>
                </p:oleObj>
              </mc:Choice>
              <mc:Fallback>
                <p:oleObj r:id="rId10" imgW="938520" imgH="1816200" progId="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5382CC82-B391-636A-AAAB-1282506B0B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55866" y="4388644"/>
                        <a:ext cx="938213" cy="181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B9C60451-ADA8-56AA-D55F-76C7CCF854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9058840"/>
              </p:ext>
            </p:extLst>
          </p:nvPr>
        </p:nvGraphicFramePr>
        <p:xfrm>
          <a:off x="2094396" y="4444530"/>
          <a:ext cx="925513" cy="1779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926280" imgH="1779840" progId="">
                  <p:embed/>
                </p:oleObj>
              </mc:Choice>
              <mc:Fallback>
                <p:oleObj r:id="rId12" imgW="926280" imgH="1779840" progId="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B9C60451-ADA8-56AA-D55F-76C7CCF854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094396" y="4444530"/>
                        <a:ext cx="925513" cy="1779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BD8872A5-FB4B-4BFF-27D1-C63DC8BA93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1522689"/>
              </p:ext>
            </p:extLst>
          </p:nvPr>
        </p:nvGraphicFramePr>
        <p:xfrm>
          <a:off x="5305908" y="4423580"/>
          <a:ext cx="938213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938520" imgH="1980720" progId="">
                  <p:embed/>
                </p:oleObj>
              </mc:Choice>
              <mc:Fallback>
                <p:oleObj r:id="rId14" imgW="938520" imgH="1980720" progId="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BD8872A5-FB4B-4BFF-27D1-C63DC8BA93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305908" y="4423580"/>
                        <a:ext cx="938213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1A470D24-C882-60D0-F48D-E0A938E3C2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089511"/>
              </p:ext>
            </p:extLst>
          </p:nvPr>
        </p:nvGraphicFramePr>
        <p:xfrm>
          <a:off x="6312056" y="4444530"/>
          <a:ext cx="779463" cy="1951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780120" imgH="1950480" progId="">
                  <p:embed/>
                </p:oleObj>
              </mc:Choice>
              <mc:Fallback>
                <p:oleObj r:id="rId16" imgW="780120" imgH="1950480" progId="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1A470D24-C882-60D0-F48D-E0A938E3C2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312056" y="4444530"/>
                        <a:ext cx="779463" cy="1951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45D8D581-02D8-EB60-6AD7-48354DD5CE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4500465"/>
              </p:ext>
            </p:extLst>
          </p:nvPr>
        </p:nvGraphicFramePr>
        <p:xfrm>
          <a:off x="3899057" y="5180479"/>
          <a:ext cx="719137" cy="44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8" imgW="719280" imgH="443160" progId="">
                  <p:embed/>
                </p:oleObj>
              </mc:Choice>
              <mc:Fallback>
                <p:oleObj r:id="rId18" imgW="719280" imgH="443160" progId="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45D8D581-02D8-EB60-6AD7-48354DD5CE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899057" y="5180479"/>
                        <a:ext cx="719137" cy="44291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D64C4F38-F38A-C473-876B-5C3EB3EFE5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027653"/>
              </p:ext>
            </p:extLst>
          </p:nvPr>
        </p:nvGraphicFramePr>
        <p:xfrm>
          <a:off x="3899056" y="4537580"/>
          <a:ext cx="719137" cy="588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0" imgW="719280" imgH="589680" progId="">
                  <p:embed/>
                </p:oleObj>
              </mc:Choice>
              <mc:Fallback>
                <p:oleObj r:id="rId20" imgW="719280" imgH="589680" progId="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D64C4F38-F38A-C473-876B-5C3EB3EFE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899056" y="4537580"/>
                        <a:ext cx="719137" cy="58896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99F19AD9-A276-6E82-C191-C411E459957A}"/>
              </a:ext>
            </a:extLst>
          </p:cNvPr>
          <p:cNvSpPr txBox="1"/>
          <p:nvPr/>
        </p:nvSpPr>
        <p:spPr>
          <a:xfrm>
            <a:off x="7188328" y="4581768"/>
            <a:ext cx="8338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actin</a:t>
            </a:r>
          </a:p>
          <a:p>
            <a:r>
              <a:rPr lang="en-US" dirty="0"/>
              <a:t>~42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0FE3D84-3B12-6367-DCDB-20479FD5615E}"/>
              </a:ext>
            </a:extLst>
          </p:cNvPr>
          <p:cNvSpPr txBox="1"/>
          <p:nvPr/>
        </p:nvSpPr>
        <p:spPr>
          <a:xfrm>
            <a:off x="4612641" y="4589518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64938A0-6FB8-1424-A7C7-813B15E3246A}"/>
              </a:ext>
            </a:extLst>
          </p:cNvPr>
          <p:cNvSpPr txBox="1"/>
          <p:nvPr/>
        </p:nvSpPr>
        <p:spPr>
          <a:xfrm>
            <a:off x="4612641" y="4811932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7 </a:t>
            </a:r>
            <a:r>
              <a:rPr lang="en-US" dirty="0" err="1"/>
              <a:t>kD</a:t>
            </a:r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2CB0BE7-6939-7DFE-DEE1-30A22E84B1A0}"/>
              </a:ext>
            </a:extLst>
          </p:cNvPr>
          <p:cNvSpPr/>
          <p:nvPr/>
        </p:nvSpPr>
        <p:spPr>
          <a:xfrm>
            <a:off x="6734014" y="1893447"/>
            <a:ext cx="380883" cy="1469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E962098-51EE-CE0B-CE39-AAD699271DEC}"/>
              </a:ext>
            </a:extLst>
          </p:cNvPr>
          <p:cNvSpPr/>
          <p:nvPr/>
        </p:nvSpPr>
        <p:spPr>
          <a:xfrm>
            <a:off x="6656522" y="4811932"/>
            <a:ext cx="439839" cy="1469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ECE454A-0F44-0881-86F3-2C3A3696D78E}"/>
              </a:ext>
            </a:extLst>
          </p:cNvPr>
          <p:cNvSpPr/>
          <p:nvPr/>
        </p:nvSpPr>
        <p:spPr>
          <a:xfrm>
            <a:off x="2606776" y="5142971"/>
            <a:ext cx="370220" cy="3023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923D4FA-FCE4-476A-5214-7A03DFE02A1C}"/>
              </a:ext>
            </a:extLst>
          </p:cNvPr>
          <p:cNvSpPr txBox="1"/>
          <p:nvPr/>
        </p:nvSpPr>
        <p:spPr>
          <a:xfrm>
            <a:off x="2958053" y="4984712"/>
            <a:ext cx="9509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Zfhx3</a:t>
            </a:r>
          </a:p>
          <a:p>
            <a:r>
              <a:rPr lang="en-US" dirty="0"/>
              <a:t>&gt;400 </a:t>
            </a:r>
            <a:r>
              <a:rPr lang="en-US" dirty="0" err="1"/>
              <a:t>kD</a:t>
            </a:r>
            <a:endParaRPr lang="en-US" dirty="0"/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B93A308-9BE9-1E75-A971-D8886B079168}"/>
              </a:ext>
            </a:extLst>
          </p:cNvPr>
          <p:cNvCxnSpPr/>
          <p:nvPr/>
        </p:nvCxnSpPr>
        <p:spPr>
          <a:xfrm flipV="1">
            <a:off x="2644064" y="1301858"/>
            <a:ext cx="1254992" cy="9609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38649F7-7146-C201-8FDB-61CAB6B93C6F}"/>
              </a:ext>
            </a:extLst>
          </p:cNvPr>
          <p:cNvCxnSpPr/>
          <p:nvPr/>
        </p:nvCxnSpPr>
        <p:spPr>
          <a:xfrm flipH="1" flipV="1">
            <a:off x="4757980" y="1763656"/>
            <a:ext cx="1790054" cy="1290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201B12D4-D8FA-2302-A72A-5DAE1D7DDD31}"/>
              </a:ext>
            </a:extLst>
          </p:cNvPr>
          <p:cNvCxnSpPr/>
          <p:nvPr/>
        </p:nvCxnSpPr>
        <p:spPr>
          <a:xfrm flipV="1">
            <a:off x="3019909" y="4695985"/>
            <a:ext cx="879147" cy="3758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81E6BB1B-6D3F-1C85-2E22-63F1D9FAEC47}"/>
              </a:ext>
            </a:extLst>
          </p:cNvPr>
          <p:cNvCxnSpPr/>
          <p:nvPr/>
        </p:nvCxnSpPr>
        <p:spPr>
          <a:xfrm flipH="1">
            <a:off x="4757980" y="5071798"/>
            <a:ext cx="2118461" cy="367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6C37386-3405-676B-54EF-40FD7F3993B2}"/>
              </a:ext>
            </a:extLst>
          </p:cNvPr>
          <p:cNvSpPr txBox="1"/>
          <p:nvPr/>
        </p:nvSpPr>
        <p:spPr>
          <a:xfrm>
            <a:off x="3920230" y="3956614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P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B4EDAE-88E8-124E-2352-FE38C507ACFB}"/>
              </a:ext>
            </a:extLst>
          </p:cNvPr>
          <p:cNvSpPr txBox="1"/>
          <p:nvPr/>
        </p:nvSpPr>
        <p:spPr>
          <a:xfrm>
            <a:off x="109334" y="6419758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polyclonal anti-ATBF1 (AT-6), MBL.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83380B-79AE-6003-ABCE-B80A8150AEC1}"/>
              </a:ext>
            </a:extLst>
          </p:cNvPr>
          <p:cNvSpPr txBox="1"/>
          <p:nvPr/>
        </p:nvSpPr>
        <p:spPr>
          <a:xfrm>
            <a:off x="126250" y="3442919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bbit polyclonal anti-ATBF1 (D1-120), MB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5FEE09-9CD6-105D-90FE-F53175C71FC8}"/>
              </a:ext>
            </a:extLst>
          </p:cNvPr>
          <p:cNvSpPr txBox="1"/>
          <p:nvPr/>
        </p:nvSpPr>
        <p:spPr>
          <a:xfrm>
            <a:off x="4612641" y="368512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Mouse Anti-</a:t>
            </a:r>
            <a:r>
              <a:rPr lang="el-GR" dirty="0"/>
              <a:t>β</a:t>
            </a:r>
            <a:r>
              <a:rPr lang="en-US" dirty="0"/>
              <a:t>Actin, Monoclonal </a:t>
            </a:r>
            <a:r>
              <a:rPr lang="en-US" dirty="0" err="1"/>
              <a:t>mAbcam</a:t>
            </a:r>
            <a:r>
              <a:rPr lang="en-US" dirty="0"/>
              <a:t> 8226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CD92A14-78A6-B15D-6D01-3A89913914DB}"/>
              </a:ext>
            </a:extLst>
          </p:cNvPr>
          <p:cNvSpPr txBox="1"/>
          <p:nvPr/>
        </p:nvSpPr>
        <p:spPr>
          <a:xfrm>
            <a:off x="4370522" y="6477295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Mouse Anti-</a:t>
            </a:r>
            <a:r>
              <a:rPr lang="el-GR" dirty="0"/>
              <a:t>β</a:t>
            </a:r>
            <a:r>
              <a:rPr lang="en-US" dirty="0"/>
              <a:t>Actin, Monoclonal </a:t>
            </a:r>
            <a:r>
              <a:rPr lang="en-US" dirty="0" err="1"/>
              <a:t>mAbcam</a:t>
            </a:r>
            <a:r>
              <a:rPr lang="en-US" dirty="0"/>
              <a:t> 8226 </a:t>
            </a:r>
          </a:p>
        </p:txBody>
      </p:sp>
    </p:spTree>
    <p:extLst>
      <p:ext uri="{BB962C8B-B14F-4D97-AF65-F5344CB8AC3E}">
        <p14:creationId xmlns:p14="http://schemas.microsoft.com/office/powerpoint/2010/main" val="2321838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5</TotalTime>
  <Words>74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na Susana Casalino Matsuda</dc:creator>
  <cp:lastModifiedBy>Marina Susana Casalino Matsuda</cp:lastModifiedBy>
  <cp:revision>2</cp:revision>
  <dcterms:created xsi:type="dcterms:W3CDTF">2023-03-07T16:38:14Z</dcterms:created>
  <dcterms:modified xsi:type="dcterms:W3CDTF">2024-01-09T23:05:18Z</dcterms:modified>
</cp:coreProperties>
</file>